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8" d="100"/>
          <a:sy n="128" d="100"/>
        </p:scale>
        <p:origin x="-1170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DC04A-AAF6-491C-A7A5-2A4E448417C2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0DF40-C5C9-407C-83F0-4BA1382F14E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831985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DC04A-AAF6-491C-A7A5-2A4E448417C2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0DF40-C5C9-407C-83F0-4BA1382F14E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927175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DC04A-AAF6-491C-A7A5-2A4E448417C2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0DF40-C5C9-407C-83F0-4BA1382F14E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868649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DC04A-AAF6-491C-A7A5-2A4E448417C2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0DF40-C5C9-407C-83F0-4BA1382F14E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403981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DC04A-AAF6-491C-A7A5-2A4E448417C2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0DF40-C5C9-407C-83F0-4BA1382F14E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884931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DC04A-AAF6-491C-A7A5-2A4E448417C2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0DF40-C5C9-407C-83F0-4BA1382F14E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989405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DC04A-AAF6-491C-A7A5-2A4E448417C2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0DF40-C5C9-407C-83F0-4BA1382F14E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63102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DC04A-AAF6-491C-A7A5-2A4E448417C2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0DF40-C5C9-407C-83F0-4BA1382F14E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863853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DC04A-AAF6-491C-A7A5-2A4E448417C2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0DF40-C5C9-407C-83F0-4BA1382F14E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112285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DC04A-AAF6-491C-A7A5-2A4E448417C2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0DF40-C5C9-407C-83F0-4BA1382F14E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23335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DDC04A-AAF6-491C-A7A5-2A4E448417C2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A0DF40-C5C9-407C-83F0-4BA1382F14E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415647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DDC04A-AAF6-491C-A7A5-2A4E448417C2}" type="datetimeFigureOut">
              <a:rPr lang="en-AU" smtClean="0"/>
              <a:t>9/08/201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A0DF40-C5C9-407C-83F0-4BA1382F14E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576002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30517" y="92333"/>
            <a:ext cx="9113484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AU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Additional file </a:t>
            </a:r>
            <a:r>
              <a:rPr kumimoji="0" lang="en-AU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8</a:t>
            </a:r>
            <a:r>
              <a:rPr kumimoji="0" lang="en-AU" sz="1200" b="1" i="0" u="none" strike="noStrike" cap="none" normalizeH="0" baseline="0" dirty="0" smtClean="0" bmk="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:</a:t>
            </a:r>
            <a:r>
              <a:rPr kumimoji="0" lang="en-AU" sz="1200" b="0" i="0" u="none" strike="noStrike" cap="none" normalizeH="0" baseline="0" dirty="0" smtClean="0" bmk="_Toc336356077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 </a:t>
            </a:r>
            <a:r>
              <a:rPr kumimoji="0" lang="en-AU" sz="1200" b="0" i="0" u="none" strike="noStrike" cap="none" normalizeH="0" baseline="0" dirty="0" smtClean="0" bmk="_Toc336356077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Frequency distribution for symptom score of </a:t>
            </a:r>
            <a:r>
              <a:rPr kumimoji="0" lang="en-AU" sz="1200" b="0" i="0" u="none" strike="noStrike" cap="none" normalizeH="0" baseline="0" dirty="0" err="1" smtClean="0" bmk="_Toc336356077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Kaspa</a:t>
            </a:r>
            <a:r>
              <a:rPr kumimoji="0" lang="en-AU" sz="1200" b="0" i="0" u="none" strike="noStrike" cap="none" normalizeH="0" baseline="0" dirty="0" smtClean="0" bmk="_Toc336356077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x Parafield RIL progeny at 7, 14, 21, 35, 42, 49 and 56 days post application of </a:t>
            </a:r>
            <a:r>
              <a:rPr kumimoji="0" lang="en-AU" sz="1200" b="0" i="0" u="none" strike="noStrike" cap="none" normalizeH="0" baseline="0" dirty="0" err="1" smtClean="0" bmk="_Toc336356077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NaCl</a:t>
            </a:r>
            <a:r>
              <a:rPr kumimoji="0" lang="en-AU" sz="1200" b="0" i="0" u="none" strike="noStrike" cap="none" normalizeH="0" baseline="0" dirty="0" smtClean="0" bmk="_Toc336356077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in watering solution at 18 dsm</a:t>
            </a:r>
            <a:r>
              <a:rPr kumimoji="0" lang="en-AU" sz="1200" b="0" i="0" u="none" strike="noStrike" cap="none" normalizeH="0" baseline="30000" dirty="0" smtClean="0" bmk="_Toc336356077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-1</a:t>
            </a:r>
            <a:r>
              <a:rPr kumimoji="0" lang="en-AU" sz="1200" b="0" i="0" u="none" strike="noStrike" cap="none" normalizeH="0" baseline="0" dirty="0" smtClean="0" bmk="_Toc336356077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.</a:t>
            </a:r>
            <a:r>
              <a:rPr kumimoji="0" lang="en-AU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> </a:t>
            </a:r>
            <a:endParaRPr kumimoji="0" lang="en-AU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8193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1600" y="980728"/>
            <a:ext cx="6840760" cy="48245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Rectangle 3"/>
          <p:cNvSpPr>
            <a:spLocks noChangeArrowheads="1"/>
          </p:cNvSpPr>
          <p:nvPr/>
        </p:nvSpPr>
        <p:spPr bwMode="auto">
          <a:xfrm>
            <a:off x="0" y="4572000"/>
            <a:ext cx="9144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AU" sz="1200" b="1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ea typeface="Times New Roman" pitchFamily="18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AU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  <a:t/>
            </a:r>
            <a:br>
              <a:rPr kumimoji="0" lang="en-AU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Times New Roman" pitchFamily="18" charset="0"/>
                <a:cs typeface="Arial" pitchFamily="34" charset="0"/>
              </a:rPr>
            </a:br>
            <a:endParaRPr kumimoji="0" lang="en-AU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72222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1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oshib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IMNA</dc:creator>
  <cp:lastModifiedBy>Shimna Sudheesh</cp:lastModifiedBy>
  <cp:revision>6</cp:revision>
  <dcterms:created xsi:type="dcterms:W3CDTF">2013-08-05T09:21:00Z</dcterms:created>
  <dcterms:modified xsi:type="dcterms:W3CDTF">2013-08-09T01:30:31Z</dcterms:modified>
</cp:coreProperties>
</file>